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906000" type="A4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>
    <p:restoredLeft sz="15623" autoAdjust="0"/>
    <p:restoredTop sz="94643" autoAdjust="0"/>
  </p:normalViewPr>
  <p:slideViewPr>
    <p:cSldViewPr>
      <p:cViewPr>
        <p:scale>
          <a:sx n="90" d="100"/>
          <a:sy n="90" d="100"/>
        </p:scale>
        <p:origin x="2778" y="-24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1E2B2-B6F8-403D-AF60-F94FC1AC8D70}" type="datetimeFigureOut">
              <a:rPr lang="en-US" smtClean="0"/>
              <a:pPr/>
              <a:t>2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E1FC2-DA93-4419-8F63-D8AA985EDB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1E2B2-B6F8-403D-AF60-F94FC1AC8D70}" type="datetimeFigureOut">
              <a:rPr lang="en-US" smtClean="0"/>
              <a:pPr/>
              <a:t>2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E1FC2-DA93-4419-8F63-D8AA985EDB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1E2B2-B6F8-403D-AF60-F94FC1AC8D70}" type="datetimeFigureOut">
              <a:rPr lang="en-US" smtClean="0"/>
              <a:pPr/>
              <a:t>2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E1FC2-DA93-4419-8F63-D8AA985EDB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1E2B2-B6F8-403D-AF60-F94FC1AC8D70}" type="datetimeFigureOut">
              <a:rPr lang="en-US" smtClean="0"/>
              <a:pPr/>
              <a:t>2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E1FC2-DA93-4419-8F63-D8AA985EDB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1E2B2-B6F8-403D-AF60-F94FC1AC8D70}" type="datetimeFigureOut">
              <a:rPr lang="en-US" smtClean="0"/>
              <a:pPr/>
              <a:t>2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E1FC2-DA93-4419-8F63-D8AA985EDB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338690"/>
            <a:ext cx="2257425" cy="94428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3338690"/>
            <a:ext cx="2257425" cy="944280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1E2B2-B6F8-403D-AF60-F94FC1AC8D70}" type="datetimeFigureOut">
              <a:rPr lang="en-US" smtClean="0"/>
              <a:pPr/>
              <a:t>2/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E1FC2-DA93-4419-8F63-D8AA985EDB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1E2B2-B6F8-403D-AF60-F94FC1AC8D70}" type="datetimeFigureOut">
              <a:rPr lang="en-US" smtClean="0"/>
              <a:pPr/>
              <a:t>2/4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E1FC2-DA93-4419-8F63-D8AA985EDB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1E2B2-B6F8-403D-AF60-F94FC1AC8D70}" type="datetimeFigureOut">
              <a:rPr lang="en-US" smtClean="0"/>
              <a:pPr/>
              <a:t>2/4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E1FC2-DA93-4419-8F63-D8AA985EDB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1E2B2-B6F8-403D-AF60-F94FC1AC8D70}" type="datetimeFigureOut">
              <a:rPr lang="en-US" smtClean="0"/>
              <a:pPr/>
              <a:t>2/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E1FC2-DA93-4419-8F63-D8AA985EDB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1E2B2-B6F8-403D-AF60-F94FC1AC8D70}" type="datetimeFigureOut">
              <a:rPr lang="en-US" smtClean="0"/>
              <a:pPr/>
              <a:t>2/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E1FC2-DA93-4419-8F63-D8AA985EDB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31E2B2-B6F8-403D-AF60-F94FC1AC8D70}" type="datetimeFigureOut">
              <a:rPr lang="en-US" smtClean="0"/>
              <a:pPr/>
              <a:t>2/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BE1FC2-DA93-4419-8F63-D8AA985EDB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31E2B2-B6F8-403D-AF60-F94FC1AC8D70}" type="datetimeFigureOut">
              <a:rPr lang="en-US" smtClean="0"/>
              <a:pPr/>
              <a:t>2/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BE1FC2-DA93-4419-8F63-D8AA985EDB1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3" Type="http://schemas.openxmlformats.org/officeDocument/2006/relationships/image" Target="../media/image7.png"/><Relationship Id="rId7" Type="http://schemas.openxmlformats.org/officeDocument/2006/relationships/image" Target="../media/image11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jpeg"/><Relationship Id="rId4" Type="http://schemas.openxmlformats.org/officeDocument/2006/relationships/image" Target="../media/image8.jpeg"/><Relationship Id="rId9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236"/>
          <p:cNvSpPr txBox="1">
            <a:spLocks noChangeArrowheads="1"/>
          </p:cNvSpPr>
          <p:nvPr/>
        </p:nvSpPr>
        <p:spPr bwMode="auto">
          <a:xfrm>
            <a:off x="1014603" y="228600"/>
            <a:ext cx="5105400" cy="144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Figure 1A, Corrected:</a:t>
            </a:r>
          </a:p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lang="en-US" dirty="0" smtClean="0">
                <a:latin typeface="Arial" pitchFamily="34" charset="0"/>
                <a:cs typeface="Arial" pitchFamily="34" charset="0"/>
              </a:rPr>
              <a:t>Uncropped replicate images for Fig. 1A: Control, DFO, 311, Hypoxia and </a:t>
            </a:r>
            <a:r>
              <a:rPr lang="en-US" dirty="0" err="1" smtClean="0">
                <a:latin typeface="Arial" pitchFamily="34" charset="0"/>
                <a:cs typeface="Arial" pitchFamily="34" charset="0"/>
              </a:rPr>
              <a:t>Tunicamycin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. Staining shows the nucleus (DAPI; blue) and eIF3a (red).</a:t>
            </a:r>
            <a:endParaRPr kumimoji="0" lang="en-US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41" y="2066520"/>
            <a:ext cx="2744860" cy="205666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41" y="4712000"/>
            <a:ext cx="2744859" cy="205666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40" y="7382572"/>
            <a:ext cx="2744859" cy="205666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0369" y="2066520"/>
            <a:ext cx="2744859" cy="205666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2140" y="4712000"/>
            <a:ext cx="2744859" cy="2056667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359540" y="1676400"/>
            <a:ext cx="889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Control</a:t>
            </a:r>
            <a:endParaRPr lang="en-AU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509388" y="4339176"/>
            <a:ext cx="590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DFO</a:t>
            </a:r>
            <a:endParaRPr lang="en-AU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536607" y="6998000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311</a:t>
            </a:r>
            <a:endParaRPr lang="en-AU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4637869" y="1676400"/>
            <a:ext cx="9575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Hypoxia</a:t>
            </a:r>
            <a:endParaRPr lang="en-AU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4434928" y="4332112"/>
            <a:ext cx="1363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err="1" smtClean="0"/>
              <a:t>Tunicamycin</a:t>
            </a:r>
            <a:endParaRPr lang="en-AU" b="1" dirty="0"/>
          </a:p>
        </p:txBody>
      </p:sp>
    </p:spTree>
    <p:extLst>
      <p:ext uri="{BB962C8B-B14F-4D97-AF65-F5344CB8AC3E}">
        <p14:creationId xmlns:p14="http://schemas.microsoft.com/office/powerpoint/2010/main" val="37279190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400" y="1905000"/>
            <a:ext cx="2412023" cy="1807280"/>
          </a:xfrm>
          <a:prstGeom prst="rect">
            <a:avLst/>
          </a:prstGeom>
        </p:spPr>
      </p:pic>
      <p:sp>
        <p:nvSpPr>
          <p:cNvPr id="4" name="Text Box 236"/>
          <p:cNvSpPr txBox="1">
            <a:spLocks noChangeArrowheads="1"/>
          </p:cNvSpPr>
          <p:nvPr/>
        </p:nvSpPr>
        <p:spPr bwMode="auto">
          <a:xfrm>
            <a:off x="533400" y="228600"/>
            <a:ext cx="5943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Figure 1B (Control,</a:t>
            </a:r>
            <a:r>
              <a:rPr kumimoji="0" lang="en-US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 left panels; DFO, right panels)</a:t>
            </a:r>
            <a:r>
              <a:rPr kumimoji="0" lang="en-US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rPr>
              <a:t>:</a:t>
            </a:r>
          </a:p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lang="en-US" dirty="0" smtClean="0">
                <a:latin typeface="Arial" pitchFamily="34" charset="0"/>
                <a:cs typeface="Arial" pitchFamily="34" charset="0"/>
              </a:rPr>
              <a:t>Uncropped images from Fig. 1B showing DAPI (blue), eIF3a (red) and eIF2</a:t>
            </a:r>
            <a:r>
              <a:rPr lang="en-US" dirty="0" smtClean="0">
                <a:latin typeface="Symbol" panose="05050102010706020507" pitchFamily="18" charset="2"/>
                <a:cs typeface="Arial" pitchFamily="34" charset="0"/>
              </a:rPr>
              <a:t>a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(green) staining.</a:t>
            </a:r>
            <a:endParaRPr kumimoji="0" lang="en-US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400" y="3810000"/>
            <a:ext cx="2412023" cy="180728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400" y="5693480"/>
            <a:ext cx="2412023" cy="180728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400" y="7598480"/>
            <a:ext cx="2412024" cy="180728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3976" y="1905000"/>
            <a:ext cx="2412023" cy="180728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3976" y="3810000"/>
            <a:ext cx="2412023" cy="180728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3976" y="5693480"/>
            <a:ext cx="2412023" cy="180728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3976" y="7598480"/>
            <a:ext cx="2412023" cy="180728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624741" y="1524000"/>
            <a:ext cx="8898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Control</a:t>
            </a:r>
            <a:endParaRPr lang="en-AU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495800" y="1524000"/>
            <a:ext cx="590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DFO</a:t>
            </a:r>
            <a:endParaRPr lang="en-AU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216773" y="2602468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eIF3a</a:t>
            </a:r>
            <a:endParaRPr lang="en-AU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28600" y="4507468"/>
            <a:ext cx="720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eIF2</a:t>
            </a:r>
            <a:r>
              <a:rPr lang="el-GR" b="1" dirty="0" smtClean="0"/>
              <a:t>α</a:t>
            </a:r>
            <a:endParaRPr lang="en-AU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28600" y="6336268"/>
            <a:ext cx="648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DAPI</a:t>
            </a:r>
            <a:endParaRPr lang="en-AU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52400" y="8317468"/>
            <a:ext cx="8030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 smtClean="0"/>
              <a:t>Merge</a:t>
            </a:r>
            <a:endParaRPr lang="en-AU" b="1" dirty="0"/>
          </a:p>
        </p:txBody>
      </p:sp>
    </p:spTree>
    <p:extLst>
      <p:ext uri="{BB962C8B-B14F-4D97-AF65-F5344CB8AC3E}">
        <p14:creationId xmlns:p14="http://schemas.microsoft.com/office/powerpoint/2010/main" val="11969129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80</TotalTime>
  <Words>84</Words>
  <Application>Microsoft Office PowerPoint</Application>
  <PresentationFormat>A4 Paper (210x297 mm)</PresentationFormat>
  <Paragraphs>1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Symbol</vt:lpstr>
      <vt:lpstr>Office Theme</vt:lpstr>
      <vt:lpstr>PowerPoint Presentation</vt:lpstr>
      <vt:lpstr>PowerPoint Presentation</vt:lpstr>
    </vt:vector>
  </TitlesOfParts>
  <Company>University of Sydne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saletta</dc:creator>
  <cp:lastModifiedBy>Ling Shu</cp:lastModifiedBy>
  <cp:revision>124</cp:revision>
  <cp:lastPrinted>2015-09-10T02:05:16Z</cp:lastPrinted>
  <dcterms:created xsi:type="dcterms:W3CDTF">2012-04-30T00:33:19Z</dcterms:created>
  <dcterms:modified xsi:type="dcterms:W3CDTF">2016-02-04T22:57:49Z</dcterms:modified>
</cp:coreProperties>
</file>